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09" r:id="rId2"/>
  </p:sldIdLst>
  <p:sldSz cx="9601200" cy="12801600" type="A3"/>
  <p:notesSz cx="6858000" cy="9144000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CEBEB"/>
    <a:srgbClr val="FEFF1C"/>
    <a:srgbClr val="FF9700"/>
    <a:srgbClr val="FFB502"/>
    <a:srgbClr val="FF0100"/>
    <a:srgbClr val="FFD302"/>
    <a:srgbClr val="FCB301"/>
    <a:srgbClr val="F69102"/>
    <a:srgbClr val="FFFF1B"/>
    <a:srgbClr val="F054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390"/>
    <p:restoredTop sz="95073"/>
  </p:normalViewPr>
  <p:slideViewPr>
    <p:cSldViewPr snapToGrid="0" snapToObjects="1">
      <p:cViewPr varScale="1">
        <p:scale>
          <a:sx n="57" d="100"/>
          <a:sy n="57" d="100"/>
        </p:scale>
        <p:origin x="3096" y="192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2A022-C9F4-0148-975C-F94539B6FB3D}" type="datetimeFigureOut">
              <a:rPr lang="en-US" smtClean="0"/>
              <a:t>5/2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2F5C-3AD8-114A-9235-54C4AB861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31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3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>
            <a:extLst>
              <a:ext uri="{FF2B5EF4-FFF2-40B4-BE49-F238E27FC236}">
                <a16:creationId xmlns:a16="http://schemas.microsoft.com/office/drawing/2014/main" id="{DCCE5288-55C0-5F44-B1F8-0F78654D13E9}"/>
              </a:ext>
            </a:extLst>
          </p:cNvPr>
          <p:cNvGrpSpPr/>
          <p:nvPr/>
        </p:nvGrpSpPr>
        <p:grpSpPr>
          <a:xfrm>
            <a:off x="166962" y="2313306"/>
            <a:ext cx="9160936" cy="5337137"/>
            <a:chOff x="166962" y="3205400"/>
            <a:chExt cx="9160936" cy="5337137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6ADC25AE-49E7-B14F-A586-026CA17CA6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6962" y="3574732"/>
              <a:ext cx="9160936" cy="4330624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E5C4F838-A985-304B-9C06-73BE4CDD7F30}"/>
                </a:ext>
              </a:extLst>
            </p:cNvPr>
            <p:cNvGrpSpPr/>
            <p:nvPr/>
          </p:nvGrpSpPr>
          <p:grpSpPr>
            <a:xfrm>
              <a:off x="713677" y="3205400"/>
              <a:ext cx="8396869" cy="5337137"/>
              <a:chOff x="713677" y="919396"/>
              <a:chExt cx="8396869" cy="5337137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A531DA0D-E7EA-8247-BFCB-B07EA90615A3}"/>
                  </a:ext>
                </a:extLst>
              </p:cNvPr>
              <p:cNvSpPr txBox="1"/>
              <p:nvPr/>
            </p:nvSpPr>
            <p:spPr>
              <a:xfrm>
                <a:off x="713677" y="5610202"/>
                <a:ext cx="839686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GB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2. 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pression pattern of a gene encoding chlorophyllase (</a:t>
                </a:r>
                <a:r>
                  <a:rPr lang="en-GB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CLH1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; </a:t>
                </a:r>
                <a:r>
                  <a:rPr lang="en-GB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clev10021103m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g) during postharvest and on-tree peel </a:t>
                </a:r>
                <a:r>
                  <a:rPr lang="en-GB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greening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n satsuma mandarin fruit. Data points represent the mean (± SE) of three fruit and different letters indicate significant differences in ANOVA (Tukey’s test, p &lt; 0.05).</a:t>
                </a:r>
                <a:r>
                  <a:rPr lang="en-GB" sz="1200" dirty="0"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AFB – Days after full bloom.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5AD5B310-E88C-B84C-89D8-CB22B3C20B9D}"/>
                  </a:ext>
                </a:extLst>
              </p:cNvPr>
              <p:cNvSpPr txBox="1"/>
              <p:nvPr/>
            </p:nvSpPr>
            <p:spPr>
              <a:xfrm>
                <a:off x="2152171" y="919396"/>
                <a:ext cx="156239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800" b="1" dirty="0">
                    <a:latin typeface="Helvetica Neue" panose="02000503000000020004" pitchFamily="2" charset="0"/>
                    <a:ea typeface="Helvetica Neue" panose="02000503000000020004" pitchFamily="2" charset="0"/>
                    <a:cs typeface="Helvetica Neue" panose="02000503000000020004" pitchFamily="2" charset="0"/>
                  </a:rPr>
                  <a:t>Postharvest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F7990A8-49BC-CB4A-8A05-896E684FE248}"/>
                  </a:ext>
                </a:extLst>
              </p:cNvPr>
              <p:cNvSpPr txBox="1"/>
              <p:nvPr/>
            </p:nvSpPr>
            <p:spPr>
              <a:xfrm>
                <a:off x="6704712" y="919396"/>
                <a:ext cx="10668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800" b="1" dirty="0">
                    <a:latin typeface="Helvetica Neue" panose="02000503000000020004" pitchFamily="2" charset="0"/>
                    <a:ea typeface="Helvetica Neue" panose="02000503000000020004" pitchFamily="2" charset="0"/>
                    <a:cs typeface="Helvetica Neue" panose="02000503000000020004" pitchFamily="2" charset="0"/>
                  </a:rPr>
                  <a:t>On-tree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69351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788</TotalTime>
  <Words>65</Words>
  <Application>Microsoft Macintosh PowerPoint</Application>
  <PresentationFormat>A3 Paper (297x420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 Neue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TALO Oscar　Witere</dc:creator>
  <cp:keywords/>
  <dc:description/>
  <cp:lastModifiedBy>Oscar Witere Mitalo</cp:lastModifiedBy>
  <cp:revision>1498</cp:revision>
  <cp:lastPrinted>2022-02-28T04:45:31Z</cp:lastPrinted>
  <dcterms:created xsi:type="dcterms:W3CDTF">2018-04-12T04:09:11Z</dcterms:created>
  <dcterms:modified xsi:type="dcterms:W3CDTF">2022-05-20T02:34:40Z</dcterms:modified>
  <cp:category/>
</cp:coreProperties>
</file>